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954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35FE1D4-D132-7B57-88C8-37176757C47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1279D90-1CF8-A45F-4709-47002FE575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FB8EE66-3716-0830-3545-88D5E293C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1FF6-BB76-4457-8146-B9AA4687FBF3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410B6D8-14AC-7EA8-C8E3-E499A70031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19FF8F-4C4A-83C6-0CD0-A5941F612F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5AFC-6940-4841-8083-29F5BCB6A0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6517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C2F9EB0-31B3-E2A1-3905-CEC1D3CAE6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F20FEF6-672E-6966-9CCA-11ABE95899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803736E-5776-A4BD-78CF-27C40FC41A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1FF6-BB76-4457-8146-B9AA4687FBF3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8749C1-66A9-1F51-717B-A57B0020A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5B7911E-219F-AE10-8559-FAFA14CBDD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5AFC-6940-4841-8083-29F5BCB6A0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0432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E3D6DDC-6D0E-E39F-8E1B-AA3630EFA53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EC0C08F-1D9E-16C9-32FC-F69B453800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FA186C-8609-7EF4-FA7F-17D3B7CCCA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1FF6-BB76-4457-8146-B9AA4687FBF3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55F6A6F-976F-5E19-D622-7B03DEBCFA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EDAF45-BDD3-1836-5BC3-B5F1FB0F07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5AFC-6940-4841-8083-29F5BCB6A0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4932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B4B842-87F8-FFAD-B3C3-576B3B6DF4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060E848-48D0-190C-73E9-E8486466338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7319A1A-8652-FE0D-7A70-2C44D6B952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1FF6-BB76-4457-8146-B9AA4687FBF3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FB752D-92B2-878D-FEE9-F33F5D2900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3E61E2A-D8D9-B5A4-D53E-AB36C75BE5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5AFC-6940-4841-8083-29F5BCB6A0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63974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CED592-6B9F-64DD-7D6E-D12A3D45BB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A50CA77-44CE-BA6C-8D04-C879B17EA8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902E3CA-3325-93D4-845B-295907D73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1FF6-BB76-4457-8146-B9AA4687FBF3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EEC03BA-A7BE-D3CD-0F05-E0C976EFE4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F8CAFBE-B6D6-29AD-6275-4F69C2E33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5AFC-6940-4841-8083-29F5BCB6A0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527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6E0445-40B7-3938-151F-2B2BA307F3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F0EE9EB-8CCE-613E-A7ED-9D370D7D0FF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E59D6D6-D9CF-EA40-6774-28141B1DFC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6C4E0EE-BCCB-1DFB-171E-4662BDD02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1FF6-BB76-4457-8146-B9AA4687FBF3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75EC929-8D6E-3B62-B71A-31492F2A43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A8BFA1D-A637-4EF8-03E9-B2ADBECAB3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5AFC-6940-4841-8083-29F5BCB6A0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6250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33A742-8736-04D4-9602-2BA63B5662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0B81FB8-BCF5-9D54-0EF3-2544E84785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6F1899C-5330-555A-AB8A-CE44CAD414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EAFED9C-26E7-0AE5-14C5-EB2A408791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1A429C9-C337-F926-E970-607E1955B5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AB7E2D5-EA84-54F7-A2B6-18C1B472A3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1FF6-BB76-4457-8146-B9AA4687FBF3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69C5B7D-BDEC-9187-6FB2-B5051B59DF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C0DFA53-3688-294B-F508-6283BBF18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5AFC-6940-4841-8083-29F5BCB6A0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0637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9512C8-D05A-C081-3772-9133698A1B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98F8E5B-7C31-38EB-C542-734D2491CB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1FF6-BB76-4457-8146-B9AA4687FBF3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3787C86-ABCE-7C93-C008-027DDD8FA9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41D8DD6-1AA0-CA19-1752-156C95201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5AFC-6940-4841-8083-29F5BCB6A0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9662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9391E45-5B2A-AE99-DE6E-9EBF21FEE3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1FF6-BB76-4457-8146-B9AA4687FBF3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EA80442-60CE-A469-30EA-974326B8C6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13D500A-753D-C09F-68E2-1E5E8C2D31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5AFC-6940-4841-8083-29F5BCB6A0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8705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63E5B5-10D3-9690-42A1-741C5477F2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52C3B88-A9D8-2454-1D27-A3E2D6D9A4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6C6563D-A31B-7ECF-72E3-059ECA5DFC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EFCA3E1-7224-953A-50C4-8BA4DCAF91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1FF6-BB76-4457-8146-B9AA4687FBF3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0EE0574-41A0-E311-4805-46C1F18DC9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7A05DE0-10A4-B30C-E219-BB3329EF5C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5AFC-6940-4841-8083-29F5BCB6A0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04649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BBA7A6-9827-1EE6-5077-0705F11A56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6A01AA7-5531-6E3E-1948-68C42C749BB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AB2C2B0-0692-450D-9B49-FD90F39A86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35162EF-3D51-59F3-DE17-60E1EBDE65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1FF6-BB76-4457-8146-B9AA4687FBF3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62F184A-59C7-97EA-B29A-BFE514919A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1B386AE-5F5E-6572-37D6-2D48853039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5AFC-6940-4841-8083-29F5BCB6A0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4272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2261B27-9860-9E61-9B9C-3C08C9844A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DB66051-7E97-488F-21DC-3243A7DDF8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ADC326C-510A-030C-3D25-2A8156E50D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D51FF6-BB76-4457-8146-B9AA4687FBF3}" type="datetimeFigureOut">
              <a:rPr lang="zh-CN" altLang="en-US" smtClean="0"/>
              <a:t>2025/10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34A774-2546-4FDD-BC81-05625AD221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93620E1-23F3-7D3D-5170-FA107FC4D57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835AFC-6940-4841-8083-29F5BCB6A0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0270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文本框 24">
            <a:extLst>
              <a:ext uri="{FF2B5EF4-FFF2-40B4-BE49-F238E27FC236}">
                <a16:creationId xmlns:a16="http://schemas.microsoft.com/office/drawing/2014/main" id="{80964AF6-1E54-EC25-1387-C62EAA326A63}"/>
              </a:ext>
            </a:extLst>
          </p:cNvPr>
          <p:cNvSpPr txBox="1"/>
          <p:nvPr/>
        </p:nvSpPr>
        <p:spPr>
          <a:xfrm>
            <a:off x="91440" y="155574"/>
            <a:ext cx="38547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blished data in Figure 3B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id="{D2F2A21E-B89E-ADE1-2D3E-5D1EBDA7079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19708" y="1185477"/>
            <a:ext cx="6352583" cy="44870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39296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B395812C-8494-6A88-7339-28788F2201B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96034882"/>
              </p:ext>
            </p:extLst>
          </p:nvPr>
        </p:nvGraphicFramePr>
        <p:xfrm>
          <a:off x="2972037" y="-38100"/>
          <a:ext cx="8432565" cy="69125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86513">
                  <a:extLst>
                    <a:ext uri="{9D8B030D-6E8A-4147-A177-3AD203B41FA5}">
                      <a16:colId xmlns:a16="http://schemas.microsoft.com/office/drawing/2014/main" val="4180092849"/>
                    </a:ext>
                  </a:extLst>
                </a:gridCol>
                <a:gridCol w="1686513">
                  <a:extLst>
                    <a:ext uri="{9D8B030D-6E8A-4147-A177-3AD203B41FA5}">
                      <a16:colId xmlns:a16="http://schemas.microsoft.com/office/drawing/2014/main" val="4122565140"/>
                    </a:ext>
                  </a:extLst>
                </a:gridCol>
                <a:gridCol w="1686513">
                  <a:extLst>
                    <a:ext uri="{9D8B030D-6E8A-4147-A177-3AD203B41FA5}">
                      <a16:colId xmlns:a16="http://schemas.microsoft.com/office/drawing/2014/main" val="84068680"/>
                    </a:ext>
                  </a:extLst>
                </a:gridCol>
                <a:gridCol w="1686513">
                  <a:extLst>
                    <a:ext uri="{9D8B030D-6E8A-4147-A177-3AD203B41FA5}">
                      <a16:colId xmlns:a16="http://schemas.microsoft.com/office/drawing/2014/main" val="78397785"/>
                    </a:ext>
                  </a:extLst>
                </a:gridCol>
                <a:gridCol w="1686513">
                  <a:extLst>
                    <a:ext uri="{9D8B030D-6E8A-4147-A177-3AD203B41FA5}">
                      <a16:colId xmlns:a16="http://schemas.microsoft.com/office/drawing/2014/main" val="2021946574"/>
                    </a:ext>
                  </a:extLst>
                </a:gridCol>
              </a:tblGrid>
              <a:tr h="399266"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trol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B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380703701"/>
                  </a:ext>
                </a:extLst>
              </a:tr>
              <a:tr h="36643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  <a:endParaRPr lang="en-US" sz="15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01.167</a:t>
                      </a:r>
                      <a:endParaRPr lang="en-US" altLang="zh-CN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50.25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8.454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15.019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extLst>
                  <a:ext uri="{0D108BD9-81ED-4DB2-BD59-A6C34878D82A}">
                    <a16:rowId xmlns:a16="http://schemas.microsoft.com/office/drawing/2014/main" val="2865589786"/>
                  </a:ext>
                </a:extLst>
              </a:tr>
              <a:tr h="272000"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37722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9578</a:t>
                      </a:r>
                      <a:endParaRPr lang="en-US" altLang="zh-CN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3792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extLst>
                  <a:ext uri="{0D108BD9-81ED-4DB2-BD59-A6C34878D82A}">
                    <a16:rowId xmlns:a16="http://schemas.microsoft.com/office/drawing/2014/main" val="2279877772"/>
                  </a:ext>
                </a:extLst>
              </a:tr>
              <a:tr h="375173"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trol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B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921022922"/>
                  </a:ext>
                </a:extLst>
              </a:tr>
              <a:tr h="3053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d</a:t>
                      </a:r>
                      <a:endParaRPr lang="en-US" sz="15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72.762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17.768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06.001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05.453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extLst>
                  <a:ext uri="{0D108BD9-81ED-4DB2-BD59-A6C34878D82A}">
                    <a16:rowId xmlns:a16="http://schemas.microsoft.com/office/drawing/2014/main" val="1191408332"/>
                  </a:ext>
                </a:extLst>
              </a:tr>
              <a:tr h="290759"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5998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9819</a:t>
                      </a:r>
                      <a:endParaRPr lang="en-US" altLang="zh-CN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655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extLst>
                  <a:ext uri="{0D108BD9-81ED-4DB2-BD59-A6C34878D82A}">
                    <a16:rowId xmlns:a16="http://schemas.microsoft.com/office/drawing/2014/main" val="2574658686"/>
                  </a:ext>
                </a:extLst>
              </a:tr>
              <a:tr h="230460"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extLst>
                  <a:ext uri="{0D108BD9-81ED-4DB2-BD59-A6C34878D82A}">
                    <a16:rowId xmlns:a16="http://schemas.microsoft.com/office/drawing/2014/main" val="4234844185"/>
                  </a:ext>
                </a:extLst>
              </a:tr>
              <a:tr h="230460"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trol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B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733842071"/>
                  </a:ext>
                </a:extLst>
              </a:tr>
              <a:tr h="230460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d/</a:t>
                      </a:r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  <a:endParaRPr lang="en-US" sz="15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4414" marR="84414" marT="42207" marB="42207" anchor="ctr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extLst>
                  <a:ext uri="{0D108BD9-81ED-4DB2-BD59-A6C34878D82A}">
                    <a16:rowId xmlns:a16="http://schemas.microsoft.com/office/drawing/2014/main" val="3727122933"/>
                  </a:ext>
                </a:extLst>
              </a:tr>
              <a:tr h="255932"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5998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1108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36081</a:t>
                      </a:r>
                      <a:endParaRPr lang="en-US" altLang="zh-CN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0903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extLst>
                  <a:ext uri="{0D108BD9-81ED-4DB2-BD59-A6C34878D82A}">
                    <a16:rowId xmlns:a16="http://schemas.microsoft.com/office/drawing/2014/main" val="3090985146"/>
                  </a:ext>
                </a:extLst>
              </a:tr>
              <a:tr h="230460"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extLst>
                  <a:ext uri="{0D108BD9-81ED-4DB2-BD59-A6C34878D82A}">
                    <a16:rowId xmlns:a16="http://schemas.microsoft.com/office/drawing/2014/main" val="1801389048"/>
                  </a:ext>
                </a:extLst>
              </a:tr>
              <a:tr h="230460"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trol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B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792499023"/>
                  </a:ext>
                </a:extLst>
              </a:tr>
              <a:tr h="2800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</a:t>
                      </a:r>
                      <a:r>
                        <a:rPr lang="en-US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xl</a:t>
                      </a:r>
                      <a:endParaRPr lang="en-US" sz="15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17.642</a:t>
                      </a:r>
                      <a:endParaRPr lang="en-US" altLang="zh-CN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08.776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73.92</a:t>
                      </a:r>
                      <a:endParaRPr lang="en-US" altLang="zh-CN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09.752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extLst>
                  <a:ext uri="{0D108BD9-81ED-4DB2-BD59-A6C34878D82A}">
                    <a16:rowId xmlns:a16="http://schemas.microsoft.com/office/drawing/2014/main" val="2033314847"/>
                  </a:ext>
                </a:extLst>
              </a:tr>
              <a:tr h="262621"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8514</a:t>
                      </a:r>
                      <a:endParaRPr lang="en-US" altLang="zh-CN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73951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4852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extLst>
                  <a:ext uri="{0D108BD9-81ED-4DB2-BD59-A6C34878D82A}">
                    <a16:rowId xmlns:a16="http://schemas.microsoft.com/office/drawing/2014/main" val="1507276330"/>
                  </a:ext>
                </a:extLst>
              </a:tr>
              <a:tr h="230460"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1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trol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B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228279877"/>
                  </a:ext>
                </a:extLst>
              </a:tr>
              <a:tr h="230460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5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</a:t>
                      </a:r>
                      <a:r>
                        <a:rPr lang="en-US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xl/</a:t>
                      </a:r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  <a:endParaRPr lang="en-US" sz="15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4414" marR="84414" marT="42207" marB="42207" anchor="ctr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extLst>
                  <a:ext uri="{0D108BD9-81ED-4DB2-BD59-A6C34878D82A}">
                    <a16:rowId xmlns:a16="http://schemas.microsoft.com/office/drawing/2014/main" val="1876853818"/>
                  </a:ext>
                </a:extLst>
              </a:tr>
              <a:tr h="268103"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3486</a:t>
                      </a:r>
                      <a:endParaRPr lang="en-US" altLang="zh-CN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1376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9303</a:t>
                      </a:r>
                      <a:endParaRPr lang="en-US" altLang="zh-CN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extLst>
                  <a:ext uri="{0D108BD9-81ED-4DB2-BD59-A6C34878D82A}">
                    <a16:rowId xmlns:a16="http://schemas.microsoft.com/office/drawing/2014/main" val="2343931686"/>
                  </a:ext>
                </a:extLst>
              </a:tr>
              <a:tr h="230460"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extLst>
                  <a:ext uri="{0D108BD9-81ED-4DB2-BD59-A6C34878D82A}">
                    <a16:rowId xmlns:a16="http://schemas.microsoft.com/office/drawing/2014/main" val="2285972133"/>
                  </a:ext>
                </a:extLst>
              </a:tr>
              <a:tr h="2304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x</a:t>
                      </a:r>
                      <a:endParaRPr lang="en-US" sz="15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trol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B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435029024"/>
                  </a:ext>
                </a:extLst>
              </a:tr>
              <a:tr h="324253"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83.572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80.553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98.406</a:t>
                      </a:r>
                      <a:endParaRPr lang="en-US" altLang="zh-CN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48.306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extLst>
                  <a:ext uri="{0D108BD9-81ED-4DB2-BD59-A6C34878D82A}">
                    <a16:rowId xmlns:a16="http://schemas.microsoft.com/office/drawing/2014/main" val="3504456879"/>
                  </a:ext>
                </a:extLst>
              </a:tr>
              <a:tr h="230460"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2607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5605</a:t>
                      </a:r>
                      <a:endParaRPr lang="en-US" altLang="zh-CN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9728</a:t>
                      </a:r>
                      <a:endParaRPr lang="en-US" altLang="zh-CN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extLst>
                  <a:ext uri="{0D108BD9-81ED-4DB2-BD59-A6C34878D82A}">
                    <a16:rowId xmlns:a16="http://schemas.microsoft.com/office/drawing/2014/main" val="1725492844"/>
                  </a:ext>
                </a:extLst>
              </a:tr>
              <a:tr h="230460"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extLst>
                  <a:ext uri="{0D108BD9-81ED-4DB2-BD59-A6C34878D82A}">
                    <a16:rowId xmlns:a16="http://schemas.microsoft.com/office/drawing/2014/main" val="1748423326"/>
                  </a:ext>
                </a:extLst>
              </a:tr>
              <a:tr h="230460"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trol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B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+NB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167172969"/>
                  </a:ext>
                </a:extLst>
              </a:tr>
              <a:tr h="230460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x/</a:t>
                      </a:r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  <a:endParaRPr lang="en-US" sz="1500" b="1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84414" marR="84414" marT="42207" marB="42207" anchor="ctr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extLst>
                  <a:ext uri="{0D108BD9-81ED-4DB2-BD59-A6C34878D82A}">
                    <a16:rowId xmlns:a16="http://schemas.microsoft.com/office/drawing/2014/main" val="2695429646"/>
                  </a:ext>
                </a:extLst>
              </a:tr>
              <a:tr h="230460">
                <a:tc>
                  <a:txBody>
                    <a:bodyPr/>
                    <a:lstStyle/>
                    <a:p>
                      <a:pPr algn="ctr" fontAlgn="ctr"/>
                      <a:endParaRPr lang="zh-CN" altLang="en-US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2607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7775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8161</a:t>
                      </a:r>
                      <a:endParaRPr lang="en-US" altLang="zh-CN" sz="15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0903</a:t>
                      </a:r>
                      <a:endParaRPr lang="en-US" altLang="zh-CN" sz="15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56" marR="5356" marT="5356" marB="0" anchor="ctr"/>
                </a:tc>
                <a:extLst>
                  <a:ext uri="{0D108BD9-81ED-4DB2-BD59-A6C34878D82A}">
                    <a16:rowId xmlns:a16="http://schemas.microsoft.com/office/drawing/2014/main" val="1702981919"/>
                  </a:ext>
                </a:extLst>
              </a:tr>
            </a:tbl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A1C4102D-C813-8E01-7719-6A7D090A2443}"/>
              </a:ext>
            </a:extLst>
          </p:cNvPr>
          <p:cNvSpPr txBox="1"/>
          <p:nvPr/>
        </p:nvSpPr>
        <p:spPr>
          <a:xfrm>
            <a:off x="85523" y="0"/>
            <a:ext cx="287074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aw data for Fig </a:t>
            </a:r>
            <a:r>
              <a:rPr lang="en-US" altLang="zh-CN" sz="2400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3B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96875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109</Words>
  <Application>Microsoft Office PowerPoint</Application>
  <PresentationFormat>宽屏</PresentationFormat>
  <Paragraphs>81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007</dc:creator>
  <cp:lastModifiedBy>007</cp:lastModifiedBy>
  <cp:revision>8</cp:revision>
  <dcterms:created xsi:type="dcterms:W3CDTF">2022-06-10T07:33:01Z</dcterms:created>
  <dcterms:modified xsi:type="dcterms:W3CDTF">2025-10-02T12:12:28Z</dcterms:modified>
</cp:coreProperties>
</file>